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1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5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79" autoAdjust="0"/>
    <p:restoredTop sz="94660"/>
  </p:normalViewPr>
  <p:slideViewPr>
    <p:cSldViewPr snapToGrid="0">
      <p:cViewPr varScale="1">
        <p:scale>
          <a:sx n="95" d="100"/>
          <a:sy n="95" d="100"/>
        </p:scale>
        <p:origin x="162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28679B-ED52-4A11-A3E8-55869F15BB8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PH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26C6C3F-CC00-4F0C-9EC0-AEAE59EC5AF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P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FAA5DE6-B88E-4D56-9F63-5F42EE9071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991F50-31DF-4B58-8B68-E609C1B78C8C}" type="datetimeFigureOut">
              <a:rPr lang="en-PH" smtClean="0"/>
              <a:t>14/11/2022</a:t>
            </a:fld>
            <a:endParaRPr lang="en-P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0E9166-ACCE-49C5-94C0-EF8B3234B5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EF58E37-804A-4D54-9F62-D615A03DB1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97CD0-DA2C-4113-B836-B4D124D82CEF}" type="slidenum">
              <a:rPr lang="en-PH" smtClean="0"/>
              <a:t>‹#›</a:t>
            </a:fld>
            <a:endParaRPr lang="en-PH"/>
          </a:p>
        </p:txBody>
      </p:sp>
    </p:spTree>
    <p:extLst>
      <p:ext uri="{BB962C8B-B14F-4D97-AF65-F5344CB8AC3E}">
        <p14:creationId xmlns:p14="http://schemas.microsoft.com/office/powerpoint/2010/main" val="40761566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CEA6E0-8753-43ED-90CC-FFEA0E0F1B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PH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F1CDFCB-C4E8-4B4C-A322-3D545D4D4CE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P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5656786-51F4-48BE-9D22-B648C28C70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991F50-31DF-4B58-8B68-E609C1B78C8C}" type="datetimeFigureOut">
              <a:rPr lang="en-PH" smtClean="0"/>
              <a:t>14/11/2022</a:t>
            </a:fld>
            <a:endParaRPr lang="en-P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26933D-8C51-4CF5-BE5C-96BB88933E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A5F8C43-BC96-41FA-8D30-C2E1D7B0E4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97CD0-DA2C-4113-B836-B4D124D82CEF}" type="slidenum">
              <a:rPr lang="en-PH" smtClean="0"/>
              <a:t>‹#›</a:t>
            </a:fld>
            <a:endParaRPr lang="en-PH"/>
          </a:p>
        </p:txBody>
      </p:sp>
    </p:spTree>
    <p:extLst>
      <p:ext uri="{BB962C8B-B14F-4D97-AF65-F5344CB8AC3E}">
        <p14:creationId xmlns:p14="http://schemas.microsoft.com/office/powerpoint/2010/main" val="4723731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B2ACB17-12BB-43D5-8C7D-CD9C024FCE1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PH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A4D617B-0BF4-49FC-A868-045A34DC88B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P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A6AFBD-8DBA-46D6-8BE8-202951E0BD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991F50-31DF-4B58-8B68-E609C1B78C8C}" type="datetimeFigureOut">
              <a:rPr lang="en-PH" smtClean="0"/>
              <a:t>14/11/2022</a:t>
            </a:fld>
            <a:endParaRPr lang="en-P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BCBC3C0-8DDE-4B88-A51A-30F2AA8226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DB3D6A5-16F8-420F-B9A5-93AAA7E39B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97CD0-DA2C-4113-B836-B4D124D82CEF}" type="slidenum">
              <a:rPr lang="en-PH" smtClean="0"/>
              <a:t>‹#›</a:t>
            </a:fld>
            <a:endParaRPr lang="en-PH"/>
          </a:p>
        </p:txBody>
      </p:sp>
    </p:spTree>
    <p:extLst>
      <p:ext uri="{BB962C8B-B14F-4D97-AF65-F5344CB8AC3E}">
        <p14:creationId xmlns:p14="http://schemas.microsoft.com/office/powerpoint/2010/main" val="21536852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F11A82-188B-4ECB-AAEC-83B9615519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PH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4283ECD-D4A5-4B29-97D5-4A5BE5D551B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P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E9617E-FA12-4068-8301-6713C5A2AF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991F50-31DF-4B58-8B68-E609C1B78C8C}" type="datetimeFigureOut">
              <a:rPr lang="en-PH" smtClean="0"/>
              <a:t>14/11/2022</a:t>
            </a:fld>
            <a:endParaRPr lang="en-P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3DB682B-3C5D-46F4-AF5C-A0AB071DDD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637D87-67C7-4046-B6BD-1E6AD0DD19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97CD0-DA2C-4113-B836-B4D124D82CEF}" type="slidenum">
              <a:rPr lang="en-PH" smtClean="0"/>
              <a:t>‹#›</a:t>
            </a:fld>
            <a:endParaRPr lang="en-PH"/>
          </a:p>
        </p:txBody>
      </p:sp>
    </p:spTree>
    <p:extLst>
      <p:ext uri="{BB962C8B-B14F-4D97-AF65-F5344CB8AC3E}">
        <p14:creationId xmlns:p14="http://schemas.microsoft.com/office/powerpoint/2010/main" val="2181371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1D3B3F-B6A2-42D3-ADA4-617607F015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PH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C9E7890-E0EA-46C2-BCBB-00ECBF779D1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88124EF-08F2-4519-9FB0-82647EA50D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991F50-31DF-4B58-8B68-E609C1B78C8C}" type="datetimeFigureOut">
              <a:rPr lang="en-PH" smtClean="0"/>
              <a:t>14/11/2022</a:t>
            </a:fld>
            <a:endParaRPr lang="en-P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81BDC2-90B3-4141-A3E2-A73F0D2B3A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B915679-84B6-40A3-B6E2-BDAF1C1DF1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97CD0-DA2C-4113-B836-B4D124D82CEF}" type="slidenum">
              <a:rPr lang="en-PH" smtClean="0"/>
              <a:t>‹#›</a:t>
            </a:fld>
            <a:endParaRPr lang="en-PH"/>
          </a:p>
        </p:txBody>
      </p:sp>
    </p:spTree>
    <p:extLst>
      <p:ext uri="{BB962C8B-B14F-4D97-AF65-F5344CB8AC3E}">
        <p14:creationId xmlns:p14="http://schemas.microsoft.com/office/powerpoint/2010/main" val="34236983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4EFF54-0C4E-4CE1-B723-000060A773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PH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DFF05CA-C251-4111-A9C3-2732CDDEE02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PH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490F3F9-738B-4411-BEE9-8789AE8AF55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PH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8A39587-7761-4D93-8A4C-429CB98009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991F50-31DF-4B58-8B68-E609C1B78C8C}" type="datetimeFigureOut">
              <a:rPr lang="en-PH" smtClean="0"/>
              <a:t>14/11/2022</a:t>
            </a:fld>
            <a:endParaRPr lang="en-PH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7380FDF-91D1-453B-8D7D-FC8ED04978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H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E0DF3A5-F8C2-4B51-A312-140CA5CD42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97CD0-DA2C-4113-B836-B4D124D82CEF}" type="slidenum">
              <a:rPr lang="en-PH" smtClean="0"/>
              <a:t>‹#›</a:t>
            </a:fld>
            <a:endParaRPr lang="en-PH"/>
          </a:p>
        </p:txBody>
      </p:sp>
    </p:spTree>
    <p:extLst>
      <p:ext uri="{BB962C8B-B14F-4D97-AF65-F5344CB8AC3E}">
        <p14:creationId xmlns:p14="http://schemas.microsoft.com/office/powerpoint/2010/main" val="35173942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3EDE93-D3F1-47EF-A8C7-75A5D41AA9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PH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1CDD1AB-00A8-42CB-AB59-2CC9B0AA8CE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E0DEFAF-2996-4C4C-A15F-53C1F2FC728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PH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6A7D957-522A-4AF4-9B34-01C00F39A8B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A99D33F-6A1D-4273-AC11-693E5C0C548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PH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3C51A0C-CE26-48CA-9C1F-2DBAE829B1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991F50-31DF-4B58-8B68-E609C1B78C8C}" type="datetimeFigureOut">
              <a:rPr lang="en-PH" smtClean="0"/>
              <a:t>14/11/2022</a:t>
            </a:fld>
            <a:endParaRPr lang="en-PH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3697E0B-2037-4898-828E-4D086C4F79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H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D93C9FC-9C2F-4E62-A46F-82B49BBE7F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97CD0-DA2C-4113-B836-B4D124D82CEF}" type="slidenum">
              <a:rPr lang="en-PH" smtClean="0"/>
              <a:t>‹#›</a:t>
            </a:fld>
            <a:endParaRPr lang="en-PH"/>
          </a:p>
        </p:txBody>
      </p:sp>
    </p:spTree>
    <p:extLst>
      <p:ext uri="{BB962C8B-B14F-4D97-AF65-F5344CB8AC3E}">
        <p14:creationId xmlns:p14="http://schemas.microsoft.com/office/powerpoint/2010/main" val="13160751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15753A-FD69-4966-8566-3B86CC95C8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PH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E975360-8A5E-440E-94A7-FB93537D85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991F50-31DF-4B58-8B68-E609C1B78C8C}" type="datetimeFigureOut">
              <a:rPr lang="en-PH" smtClean="0"/>
              <a:t>14/11/2022</a:t>
            </a:fld>
            <a:endParaRPr lang="en-PH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C73BB56-E7FE-45F5-A928-58EC2663E4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H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8D14419-5FEB-4288-8BA9-A769F8D416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97CD0-DA2C-4113-B836-B4D124D82CEF}" type="slidenum">
              <a:rPr lang="en-PH" smtClean="0"/>
              <a:t>‹#›</a:t>
            </a:fld>
            <a:endParaRPr lang="en-PH"/>
          </a:p>
        </p:txBody>
      </p:sp>
    </p:spTree>
    <p:extLst>
      <p:ext uri="{BB962C8B-B14F-4D97-AF65-F5344CB8AC3E}">
        <p14:creationId xmlns:p14="http://schemas.microsoft.com/office/powerpoint/2010/main" val="42734005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9982A7F-4B42-4807-972D-49C26458AD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991F50-31DF-4B58-8B68-E609C1B78C8C}" type="datetimeFigureOut">
              <a:rPr lang="en-PH" smtClean="0"/>
              <a:t>14/11/2022</a:t>
            </a:fld>
            <a:endParaRPr lang="en-PH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DDF201F-18FF-4135-8CEC-5F003E5EB5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H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7E22183-D0EB-4264-A532-F894812FD0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97CD0-DA2C-4113-B836-B4D124D82CEF}" type="slidenum">
              <a:rPr lang="en-PH" smtClean="0"/>
              <a:t>‹#›</a:t>
            </a:fld>
            <a:endParaRPr lang="en-PH"/>
          </a:p>
        </p:txBody>
      </p:sp>
    </p:spTree>
    <p:extLst>
      <p:ext uri="{BB962C8B-B14F-4D97-AF65-F5344CB8AC3E}">
        <p14:creationId xmlns:p14="http://schemas.microsoft.com/office/powerpoint/2010/main" val="17710027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C01579-4F87-4F30-AFEA-08843CBB8E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PH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CBC70BF-7A6B-45A4-A85F-DA66ADD789D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PH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AD78B82-F76B-405E-9832-6493B579177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5B7EBEC-B43F-4116-A6C0-DF536650B8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991F50-31DF-4B58-8B68-E609C1B78C8C}" type="datetimeFigureOut">
              <a:rPr lang="en-PH" smtClean="0"/>
              <a:t>14/11/2022</a:t>
            </a:fld>
            <a:endParaRPr lang="en-PH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7A0855E-123F-4F70-9360-31863E44E2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H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949B572-031A-4FC7-A41C-C284909460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97CD0-DA2C-4113-B836-B4D124D82CEF}" type="slidenum">
              <a:rPr lang="en-PH" smtClean="0"/>
              <a:t>‹#›</a:t>
            </a:fld>
            <a:endParaRPr lang="en-PH"/>
          </a:p>
        </p:txBody>
      </p:sp>
    </p:spTree>
    <p:extLst>
      <p:ext uri="{BB962C8B-B14F-4D97-AF65-F5344CB8AC3E}">
        <p14:creationId xmlns:p14="http://schemas.microsoft.com/office/powerpoint/2010/main" val="38948205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F970D0-7461-49B5-A7C2-0E322E10C7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PH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C9AA07D-9EA7-456C-AAB5-A52AE83141E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PH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FDA3ABD-08BF-448A-900D-02AA56D8A45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05D2474-F184-45F3-B161-FA1B62042E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991F50-31DF-4B58-8B68-E609C1B78C8C}" type="datetimeFigureOut">
              <a:rPr lang="en-PH" smtClean="0"/>
              <a:t>14/11/2022</a:t>
            </a:fld>
            <a:endParaRPr lang="en-PH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237ED05-DEFD-4D64-9AE0-19EF296B87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H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5F5B64E-2FB4-4DAC-BD48-2BBD6AEB36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97CD0-DA2C-4113-B836-B4D124D82CEF}" type="slidenum">
              <a:rPr lang="en-PH" smtClean="0"/>
              <a:t>‹#›</a:t>
            </a:fld>
            <a:endParaRPr lang="en-PH"/>
          </a:p>
        </p:txBody>
      </p:sp>
    </p:spTree>
    <p:extLst>
      <p:ext uri="{BB962C8B-B14F-4D97-AF65-F5344CB8AC3E}">
        <p14:creationId xmlns:p14="http://schemas.microsoft.com/office/powerpoint/2010/main" val="28835048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BB60531-68CE-4517-A122-8E8E977FF9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PH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9DC869B-A4DA-47DA-B743-11D6473932B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P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0A4DB36-1F74-4657-95D8-987B9A38210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991F50-31DF-4B58-8B68-E609C1B78C8C}" type="datetimeFigureOut">
              <a:rPr lang="en-PH" smtClean="0"/>
              <a:t>14/11/2022</a:t>
            </a:fld>
            <a:endParaRPr lang="en-P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AB6CA2-EE23-4E4E-84EC-4102FDA141F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P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BCF49B1-B06F-4755-84D9-74D57D8337C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097CD0-DA2C-4113-B836-B4D124D82CEF}" type="slidenum">
              <a:rPr lang="en-PH" smtClean="0"/>
              <a:t>‹#›</a:t>
            </a:fld>
            <a:endParaRPr lang="en-PH"/>
          </a:p>
        </p:txBody>
      </p:sp>
    </p:spTree>
    <p:extLst>
      <p:ext uri="{BB962C8B-B14F-4D97-AF65-F5344CB8AC3E}">
        <p14:creationId xmlns:p14="http://schemas.microsoft.com/office/powerpoint/2010/main" val="34709413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tags" Target="../tags/tag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/>
          <p:cNvGraphicFramePr/>
          <p:nvPr>
            <p:custDataLst>
              <p:tags r:id="rId1"/>
            </p:custDataLst>
          </p:nvPr>
        </p:nvGraphicFramePr>
        <p:xfrm>
          <a:off x="1645920" y="852170"/>
          <a:ext cx="6186170" cy="4566285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94234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24726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99656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51625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1" dirty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Primer Name</a:t>
                      </a:r>
                      <a:endParaRPr lang="en-US" altLang="en-US" sz="1100" b="1" dirty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UP</a:t>
                      </a:r>
                      <a:endParaRPr lang="en-US" altLang="en-US" sz="11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DN</a:t>
                      </a:r>
                      <a:endParaRPr lang="en-US" altLang="en-US" sz="11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qPCR-</a:t>
                      </a:r>
                      <a:r>
                        <a:rPr lang="en-US" sz="800" b="0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ZmRop1</a:t>
                      </a:r>
                      <a:endParaRPr lang="en-US" altLang="en-US" sz="800" b="0" i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AGGATGTTCTATGATGAACATCTTCGG</a:t>
                      </a:r>
                      <a:endParaRPr lang="en-US" altLang="en-US" sz="8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CTGCTTAACTCATAGAGCTAACCACAC</a:t>
                      </a:r>
                      <a:endParaRPr lang="en-US" altLang="en-US" sz="8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3685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qPCR-</a:t>
                      </a:r>
                      <a:r>
                        <a:rPr lang="en-US" sz="800" b="0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ZmRop2</a:t>
                      </a:r>
                      <a:endParaRPr lang="en-US" altLang="en-US" sz="800" b="0" i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GCTCCATACTACATCGAATGCAGCTCG</a:t>
                      </a:r>
                      <a:endParaRPr lang="en-US" altLang="en-US" sz="8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TCTTTTGCTCAAACACGGGAAATACCTTCT</a:t>
                      </a:r>
                      <a:endParaRPr lang="en-US" altLang="en-US" sz="8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qPCR-</a:t>
                      </a:r>
                      <a:r>
                        <a:rPr lang="en-US" sz="800" b="0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ZmRop3</a:t>
                      </a:r>
                      <a:endParaRPr lang="en-US" altLang="en-US" sz="800" b="0" i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ATGTTGATGCTGGCATGGCC</a:t>
                      </a:r>
                      <a:endParaRPr lang="en-US" altLang="en-US" sz="8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800" b="0" dirty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TTACCTGTTCAGTAGAGATGATG</a:t>
                      </a:r>
                      <a:endParaRPr lang="en-US" altLang="en-US" sz="800" b="0" dirty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3685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qPCR-</a:t>
                      </a:r>
                      <a:r>
                        <a:rPr lang="en-US" sz="800" b="0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ZmRop4</a:t>
                      </a:r>
                      <a:endParaRPr lang="en-US" altLang="en-US" sz="800" b="0" i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CCAGCCACCAAAGCAAAAGAAGAGG</a:t>
                      </a:r>
                      <a:endParaRPr lang="en-US" altLang="en-US" sz="8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CCATCTGCAGTGCTAGTTTTGTCTTGTCC</a:t>
                      </a:r>
                      <a:endParaRPr lang="en-US" altLang="en-US" sz="8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qPCR-</a:t>
                      </a:r>
                      <a:r>
                        <a:rPr lang="en-US" sz="800" b="0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ZmRop5</a:t>
                      </a:r>
                      <a:endParaRPr lang="en-US" altLang="en-US" sz="800" b="0" i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TGTTGGCCGGAACTAAATTGGATCTTC</a:t>
                      </a:r>
                      <a:endParaRPr lang="en-US" altLang="en-US" sz="8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CGAGCACTTTGGAACATGGAGACAAAC</a:t>
                      </a:r>
                      <a:endParaRPr lang="en-US" altLang="en-US" sz="8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qPCR-</a:t>
                      </a:r>
                      <a:r>
                        <a:rPr lang="en-US" sz="800" b="0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ZmRop6</a:t>
                      </a:r>
                      <a:endParaRPr lang="en-US" altLang="en-US" sz="800" b="0" i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TCCGCGACCACAGAGCCTACCTC</a:t>
                      </a:r>
                      <a:endParaRPr lang="en-US" altLang="en-US" sz="8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TCAGCCCTTGAAGAGCCTGACGAACT</a:t>
                      </a:r>
                      <a:endParaRPr lang="en-US" altLang="en-US" sz="8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3685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qPCR-</a:t>
                      </a:r>
                      <a:r>
                        <a:rPr lang="en-US" sz="800" b="0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ZmRop7</a:t>
                      </a:r>
                      <a:endParaRPr lang="en-US" altLang="en-US" sz="800" b="0" i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ATGTCAAGTCGGTCTTCGAC</a:t>
                      </a:r>
                      <a:endParaRPr lang="en-US" altLang="en-US" sz="8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TCATGATAGAGCACCCGGAG</a:t>
                      </a:r>
                      <a:endParaRPr lang="en-US" altLang="en-US" sz="8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8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qPCR-</a:t>
                      </a:r>
                      <a:r>
                        <a:rPr lang="en-US" sz="800" b="0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ZmRop8</a:t>
                      </a:r>
                      <a:endParaRPr lang="en-US" altLang="en-US" sz="800" b="0" i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GTGGGGTGCCTGTTGTGTTGGT</a:t>
                      </a:r>
                      <a:endParaRPr lang="en-US" altLang="en-US" sz="8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CAGGTAAGACCCCCTTCGATCATTCAG</a:t>
                      </a:r>
                      <a:endParaRPr lang="en-US" altLang="en-US" sz="8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800" b="0" dirty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qPCR-</a:t>
                      </a:r>
                      <a:r>
                        <a:rPr lang="en-US" sz="800" b="0" i="1" dirty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ZmRop9</a:t>
                      </a:r>
                      <a:endParaRPr lang="en-US" altLang="en-US" sz="800" b="0" i="1" dirty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800" b="0" dirty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CGCCATACTACATCGAGTGCAGCTCA</a:t>
                      </a:r>
                      <a:endParaRPr lang="en-US" altLang="en-US" sz="800" b="0" dirty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GACTCGCTGCAGCCGCCAG</a:t>
                      </a:r>
                      <a:endParaRPr lang="en-US" altLang="en-US" sz="8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3685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800" b="0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ZmUBI</a:t>
                      </a:r>
                      <a:endParaRPr lang="en-US" altLang="en-US" sz="800" b="0" i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GGAAAAACCATAACCCTGGA</a:t>
                      </a:r>
                      <a:endParaRPr lang="en-US" altLang="en-US" sz="8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ATATGGAGAGAGGGCACCAG</a:t>
                      </a:r>
                      <a:endParaRPr lang="en-US" altLang="en-US" sz="8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6670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800" b="0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ZmRop1</a:t>
                      </a:r>
                      <a:endParaRPr lang="en-US" altLang="en-US" sz="800" b="0" i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TATCTAGAATGGCGTCCAGCGCCTCTC</a:t>
                      </a:r>
                      <a:endParaRPr lang="en-US" altLang="en-US" sz="8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TGGATCCTCAGGACTTGAAGCATAGCATTTTTCTTCCAC</a:t>
                      </a:r>
                      <a:endParaRPr lang="en-US" altLang="en-US" sz="8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altLang="en-US" sz="800" b="0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ZmRop1</a:t>
                      </a:r>
                      <a:r>
                        <a:rPr lang="en-US" altLang="en-US" sz="8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-VIGS</a:t>
                      </a: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altLang="en-US" sz="8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GCTCTAGATATTACATTGAATGCAGCTC</a:t>
                      </a: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altLang="en-US" sz="8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CGGGATCCTCAGGACTTGAAGCATA</a:t>
                      </a: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800" b="0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ZmCAT</a:t>
                      </a:r>
                      <a:endParaRPr lang="en-US" altLang="en-US" sz="800" b="0" i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CAGGCTGTCGTGAGAAGTGC</a:t>
                      </a:r>
                      <a:endParaRPr lang="en-US" altLang="en-US" sz="8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GAGATCCAAATGGTACGGTGTT</a:t>
                      </a:r>
                      <a:endParaRPr lang="en-US" altLang="en-US" sz="8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3685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800" b="0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ZmPOD</a:t>
                      </a:r>
                      <a:endParaRPr lang="en-US" altLang="en-US" sz="800" b="0" i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TGGACAACAACTACTACAAG</a:t>
                      </a:r>
                      <a:endParaRPr lang="en-US" altLang="en-US" sz="8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TGCTTATTATTACCCGCCAC</a:t>
                      </a:r>
                      <a:endParaRPr lang="en-US" altLang="en-US" sz="8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800" b="0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ZmPPO</a:t>
                      </a:r>
                      <a:endParaRPr lang="en-US" altLang="en-US" sz="800" b="0" i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ATGCAGCCTCCAAGCCGCA</a:t>
                      </a:r>
                      <a:endParaRPr lang="en-US" altLang="en-US" sz="8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TTACTCGCGATCCCGGCAG</a:t>
                      </a:r>
                      <a:endParaRPr lang="en-US" altLang="en-US" sz="8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23685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800" b="0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ZmrbohA</a:t>
                      </a:r>
                      <a:endParaRPr lang="en-US" altLang="en-US" sz="800" b="0" i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ATGACATTCTTCTGCTTATTGGC</a:t>
                      </a:r>
                      <a:endParaRPr lang="en-US" altLang="en-US" sz="8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ATGCTTCCCACCTCTTCGTT</a:t>
                      </a:r>
                      <a:endParaRPr lang="en-US" altLang="en-US" sz="8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800" b="0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ZmrbohB</a:t>
                      </a:r>
                      <a:endParaRPr lang="en-US" altLang="en-US" sz="800" b="0" i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8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ACCCTTTGAATGGCATCCG</a:t>
                      </a:r>
                      <a:endParaRPr lang="en-US" altLang="en-US" sz="8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800" b="0" dirty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AAGGAGTTGCACCAATCCCTAAT</a:t>
                      </a:r>
                      <a:endParaRPr lang="en-US" altLang="en-US" sz="800" b="0" dirty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TABLE_BEAUTIFY" val="smartTable{48a85bac-b3be-406f-901e-aed2cf07dcae}"/>
  <p:tag name="TABLE_ENDDRAG_ORIGIN_RECT" val="487*351"/>
  <p:tag name="TABLE_ENDDRAG_RECT" val="115*59*487*351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5</Words>
  <Application>Microsoft Office PowerPoint</Application>
  <PresentationFormat>Widescreen</PresentationFormat>
  <Paragraphs>5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aldivia, Noelito -</dc:creator>
  <cp:lastModifiedBy>Valdivia, Noelito -</cp:lastModifiedBy>
  <cp:revision>1</cp:revision>
  <dcterms:created xsi:type="dcterms:W3CDTF">2022-11-14T06:25:00Z</dcterms:created>
  <dcterms:modified xsi:type="dcterms:W3CDTF">2022-11-14T06:25:13Z</dcterms:modified>
</cp:coreProperties>
</file>